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AFD223-53E5-4FF3-BC09-FE455974B9E4}" v="3" dt="2025-07-09T19:47:36.058"/>
    <p1510:client id="{80991548-4828-4B0C-8472-EAC2B0178C3A}" v="4" dt="2025-07-09T19:35:46.2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–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87" y="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s, Daniel" userId="bd69870e-14b0-4b2a-a293-a297d41864dd" providerId="ADAL" clId="{F360EA8D-2CEF-44DC-A095-62624361F870}"/>
    <pc:docChg chg="custSel addSld modSld">
      <pc:chgData name="Davids, Daniel" userId="bd69870e-14b0-4b2a-a293-a297d41864dd" providerId="ADAL" clId="{F360EA8D-2CEF-44DC-A095-62624361F870}" dt="2024-11-03T19:02:12.238" v="30" actId="1035"/>
      <pc:docMkLst>
        <pc:docMk/>
      </pc:docMkLst>
      <pc:sldChg chg="addSp delSp modSp mod">
        <pc:chgData name="Davids, Daniel" userId="bd69870e-14b0-4b2a-a293-a297d41864dd" providerId="ADAL" clId="{F360EA8D-2CEF-44DC-A095-62624361F870}" dt="2024-11-03T19:02:12.238" v="30" actId="1035"/>
        <pc:sldMkLst>
          <pc:docMk/>
          <pc:sldMk cId="174092475" sldId="257"/>
        </pc:sldMkLst>
      </pc:sldChg>
      <pc:sldChg chg="delSp modSp add mod">
        <pc:chgData name="Davids, Daniel" userId="bd69870e-14b0-4b2a-a293-a297d41864dd" providerId="ADAL" clId="{F360EA8D-2CEF-44DC-A095-62624361F870}" dt="2024-11-03T18:56:55.974" v="23" actId="20577"/>
        <pc:sldMkLst>
          <pc:docMk/>
          <pc:sldMk cId="3475097194" sldId="258"/>
        </pc:sldMkLst>
      </pc:sldChg>
    </pc:docChg>
  </pc:docChgLst>
  <pc:docChgLst>
    <pc:chgData name="Davids, Daniel" userId="bd69870e-14b0-4b2a-a293-a297d41864dd" providerId="ADAL" clId="{7AAFD223-53E5-4FF3-BC09-FE455974B9E4}"/>
    <pc:docChg chg="custSel modSld">
      <pc:chgData name="Davids, Daniel" userId="bd69870e-14b0-4b2a-a293-a297d41864dd" providerId="ADAL" clId="{7AAFD223-53E5-4FF3-BC09-FE455974B9E4}" dt="2025-07-09T19:47:41.359" v="3" actId="1076"/>
      <pc:docMkLst>
        <pc:docMk/>
      </pc:docMkLst>
      <pc:sldChg chg="addSp delSp modSp mod">
        <pc:chgData name="Davids, Daniel" userId="bd69870e-14b0-4b2a-a293-a297d41864dd" providerId="ADAL" clId="{7AAFD223-53E5-4FF3-BC09-FE455974B9E4}" dt="2025-07-09T19:47:41.359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7AAFD223-53E5-4FF3-BC09-FE455974B9E4}" dt="2025-07-09T19:47:31.039" v="1"/>
          <ac:graphicFrameMkLst>
            <pc:docMk/>
            <pc:sldMk cId="174092475" sldId="257"/>
            <ac:graphicFrameMk id="2" creationId="{7071A138-DA6E-95FC-8747-FB6637BA62A3}"/>
          </ac:graphicFrameMkLst>
        </pc:graphicFrameChg>
        <pc:graphicFrameChg chg="add mod">
          <ac:chgData name="Davids, Daniel" userId="bd69870e-14b0-4b2a-a293-a297d41864dd" providerId="ADAL" clId="{7AAFD223-53E5-4FF3-BC09-FE455974B9E4}" dt="2025-07-09T19:47:41.359" v="3" actId="1076"/>
          <ac:graphicFrameMkLst>
            <pc:docMk/>
            <pc:sldMk cId="174092475" sldId="257"/>
            <ac:graphicFrameMk id="3" creationId="{662DDD7D-F850-0B47-F8B8-313601DB79AC}"/>
          </ac:graphicFrameMkLst>
        </pc:graphicFrameChg>
        <pc:graphicFrameChg chg="del">
          <ac:chgData name="Davids, Daniel" userId="bd69870e-14b0-4b2a-a293-a297d41864dd" providerId="ADAL" clId="{7AAFD223-53E5-4FF3-BC09-FE455974B9E4}" dt="2025-07-09T19:47:20.729" v="0" actId="478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  <pc:docChgLst>
    <pc:chgData name="Davids, Daniel" userId="bd69870e-14b0-4b2a-a293-a297d41864dd" providerId="ADAL" clId="{6A553EA6-244C-48F8-95FD-828D1717A47C}"/>
    <pc:docChg chg="custSel addSld delSld modSld">
      <pc:chgData name="Davids, Daniel" userId="bd69870e-14b0-4b2a-a293-a297d41864dd" providerId="ADAL" clId="{6A553EA6-244C-48F8-95FD-828D1717A47C}" dt="2025-03-05T23:50:11.992" v="16" actId="1076"/>
      <pc:docMkLst>
        <pc:docMk/>
      </pc:docMkLst>
      <pc:sldChg chg="addSp delSp modSp mod">
        <pc:chgData name="Davids, Daniel" userId="bd69870e-14b0-4b2a-a293-a297d41864dd" providerId="ADAL" clId="{6A553EA6-244C-48F8-95FD-828D1717A47C}" dt="2025-03-05T23:50:11.992" v="16" actId="1076"/>
        <pc:sldMkLst>
          <pc:docMk/>
          <pc:sldMk cId="174092475" sldId="257"/>
        </pc:sldMkLst>
      </pc:sldChg>
      <pc:sldChg chg="del">
        <pc:chgData name="Davids, Daniel" userId="bd69870e-14b0-4b2a-a293-a297d41864dd" providerId="ADAL" clId="{6A553EA6-244C-48F8-95FD-828D1717A47C}" dt="2025-03-05T21:20:23.750" v="3" actId="47"/>
        <pc:sldMkLst>
          <pc:docMk/>
          <pc:sldMk cId="3475097194" sldId="258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4035310119" sldId="259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3572187018" sldId="260"/>
        </pc:sldMkLst>
      </pc:sldChg>
    </pc:docChg>
  </pc:docChgLst>
  <pc:docChgLst>
    <pc:chgData name="Davids, Daniel" userId="bd69870e-14b0-4b2a-a293-a297d41864dd" providerId="ADAL" clId="{B0D606D2-1008-41BC-A72F-F713ABC021F4}"/>
    <pc:docChg chg="addSld delSld modSld">
      <pc:chgData name="Davids, Daniel" userId="bd69870e-14b0-4b2a-a293-a297d41864dd" providerId="ADAL" clId="{B0D606D2-1008-41BC-A72F-F713ABC021F4}" dt="2024-11-03T18:32:44.267" v="35" actId="47"/>
      <pc:docMkLst>
        <pc:docMk/>
      </pc:docMkLst>
      <pc:sldChg chg="new del">
        <pc:chgData name="Davids, Daniel" userId="bd69870e-14b0-4b2a-a293-a297d41864dd" providerId="ADAL" clId="{B0D606D2-1008-41BC-A72F-F713ABC021F4}" dt="2024-11-03T18:19:33.782" v="2" actId="47"/>
        <pc:sldMkLst>
          <pc:docMk/>
          <pc:sldMk cId="2106742275" sldId="256"/>
        </pc:sldMkLst>
      </pc:sldChg>
      <pc:sldChg chg="addSp delSp modSp new mod">
        <pc:chgData name="Davids, Daniel" userId="bd69870e-14b0-4b2a-a293-a297d41864dd" providerId="ADAL" clId="{B0D606D2-1008-41BC-A72F-F713ABC021F4}" dt="2024-11-03T18:31:45.297" v="32" actId="14100"/>
        <pc:sldMkLst>
          <pc:docMk/>
          <pc:sldMk cId="174092475" sldId="25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261132528" sldId="25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129412391" sldId="259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459212972" sldId="260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83949308" sldId="261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847408672" sldId="262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10391834" sldId="263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546292502" sldId="264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35228439" sldId="265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002150119" sldId="266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2056411075" sldId="26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923372120" sldId="26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752528510" sldId="269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2664668440" sldId="270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107856901" sldId="271"/>
        </pc:sldMkLst>
      </pc:sldChg>
      <pc:sldChg chg="add del">
        <pc:chgData name="Davids, Daniel" userId="bd69870e-14b0-4b2a-a293-a297d41864dd" providerId="ADAL" clId="{B0D606D2-1008-41BC-A72F-F713ABC021F4}" dt="2024-11-03T18:32:32.890" v="33" actId="47"/>
        <pc:sldMkLst>
          <pc:docMk/>
          <pc:sldMk cId="1885141936" sldId="272"/>
        </pc:sldMkLst>
      </pc:sldChg>
    </pc:docChg>
  </pc:docChgLst>
  <pc:docChgLst>
    <pc:chgData name="Davids, Daniel" userId="bd69870e-14b0-4b2a-a293-a297d41864dd" providerId="ADAL" clId="{80991548-4828-4B0C-8472-EAC2B0178C3A}"/>
    <pc:docChg chg="custSel modSld">
      <pc:chgData name="Davids, Daniel" userId="bd69870e-14b0-4b2a-a293-a297d41864dd" providerId="ADAL" clId="{80991548-4828-4B0C-8472-EAC2B0178C3A}" dt="2025-07-09T19:35:53.748" v="3" actId="1076"/>
      <pc:docMkLst>
        <pc:docMk/>
      </pc:docMkLst>
      <pc:sldChg chg="addSp delSp modSp mod">
        <pc:chgData name="Davids, Daniel" userId="bd69870e-14b0-4b2a-a293-a297d41864dd" providerId="ADAL" clId="{80991548-4828-4B0C-8472-EAC2B0178C3A}" dt="2025-07-09T19:35:53.748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80991548-4828-4B0C-8472-EAC2B0178C3A}" dt="2025-07-09T19:35:38.190" v="1"/>
          <ac:graphicFrameMkLst>
            <pc:docMk/>
            <pc:sldMk cId="174092475" sldId="257"/>
            <ac:graphicFrameMk id="2" creationId="{E32B4A51-178D-C890-AB83-2FB66FFC672E}"/>
          </ac:graphicFrameMkLst>
        </pc:graphicFrameChg>
        <pc:graphicFrameChg chg="del">
          <ac:chgData name="Davids, Daniel" userId="bd69870e-14b0-4b2a-a293-a297d41864dd" providerId="ADAL" clId="{80991548-4828-4B0C-8472-EAC2B0178C3A}" dt="2025-07-09T19:33:30.622" v="0" actId="478"/>
          <ac:graphicFrameMkLst>
            <pc:docMk/>
            <pc:sldMk cId="174092475" sldId="257"/>
            <ac:graphicFrameMk id="3" creationId="{628EA2F4-7C09-610F-3DE6-012586300E54}"/>
          </ac:graphicFrameMkLst>
        </pc:graphicFrameChg>
        <pc:graphicFrameChg chg="add mod">
          <ac:chgData name="Davids, Daniel" userId="bd69870e-14b0-4b2a-a293-a297d41864dd" providerId="ADAL" clId="{80991548-4828-4B0C-8472-EAC2B0178C3A}" dt="2025-07-09T19:35:53.748" v="3" actId="1076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6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6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9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2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56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24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8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67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29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6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62DDD7D-F850-0B47-F8B8-313601DB79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2952027"/>
              </p:ext>
            </p:extLst>
          </p:nvPr>
        </p:nvGraphicFramePr>
        <p:xfrm>
          <a:off x="2587308" y="2159921"/>
          <a:ext cx="6912610" cy="1777746"/>
        </p:xfrm>
        <a:graphic>
          <a:graphicData uri="http://schemas.openxmlformats.org/drawingml/2006/table">
            <a:tbl>
              <a:tblPr firstRow="1" firstCol="1" bandRow="1"/>
              <a:tblGrid>
                <a:gridCol w="1890395">
                  <a:extLst>
                    <a:ext uri="{9D8B030D-6E8A-4147-A177-3AD203B41FA5}">
                      <a16:colId xmlns:a16="http://schemas.microsoft.com/office/drawing/2014/main" val="2686185191"/>
                    </a:ext>
                  </a:extLst>
                </a:gridCol>
                <a:gridCol w="1495425">
                  <a:extLst>
                    <a:ext uri="{9D8B030D-6E8A-4147-A177-3AD203B41FA5}">
                      <a16:colId xmlns:a16="http://schemas.microsoft.com/office/drawing/2014/main" val="1798967121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3901151271"/>
                    </a:ext>
                  </a:extLst>
                </a:gridCol>
                <a:gridCol w="1139190">
                  <a:extLst>
                    <a:ext uri="{9D8B030D-6E8A-4147-A177-3AD203B41FA5}">
                      <a16:colId xmlns:a16="http://schemas.microsoft.com/office/drawing/2014/main" val="2343851430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972503457"/>
                    </a:ext>
                  </a:extLst>
                </a:gridCol>
              </a:tblGrid>
              <a:tr h="182880">
                <a:tc gridSpan="5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y = Intercept + B1*x^1 + B2*x^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68026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o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5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0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7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279797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rcep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05138 ± 0.0080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0363 ± 0.0098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07409 ± 0.0082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09029 ± 0.0044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19836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9323 ± 0.038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19852 ± 0.053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45377 ± 0.0528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4324 ± 0.03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882949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31995 ± 0.0388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43642 ± 0.0606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67645 ± 0.067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75452 ± 0.040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26058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sidual Sum of Squa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13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19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.39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37E-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181995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-Square (CO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8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6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6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8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45254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. R-Squa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6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2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3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97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809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09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102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s, Daniel</dc:creator>
  <cp:lastModifiedBy>Davids, Daniel</cp:lastModifiedBy>
  <cp:revision>1</cp:revision>
  <dcterms:created xsi:type="dcterms:W3CDTF">2024-11-03T18:19:26Z</dcterms:created>
  <dcterms:modified xsi:type="dcterms:W3CDTF">2025-07-09T19:47:43Z</dcterms:modified>
</cp:coreProperties>
</file>